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5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8"/>
  </p:normalViewPr>
  <p:slideViewPr>
    <p:cSldViewPr snapToGrid="0">
      <p:cViewPr varScale="1">
        <p:scale>
          <a:sx n="112" d="100"/>
          <a:sy n="112" d="100"/>
        </p:scale>
        <p:origin x="48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nori\Dropbox\&#9734;NCNP\&#23567;&#20816;&#12450;&#12463;&#12481;\demographic_ALL_20210907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nori\Dropbox\&#9734;NCNP\&#23567;&#20816;&#12450;&#12463;&#12481;\demographic_ALL_20210907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nori\Dropbox\&#9734;NCNP\&#23567;&#20816;&#12450;&#12463;&#12481;\demographic_ALL_20210907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7997684659441"/>
          <c:y val="2.8388075966963196E-2"/>
          <c:w val="0.82693867592110715"/>
          <c:h val="0.8868089527821079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WS_AC!$BA$21</c:f>
              <c:strCache>
                <c:ptCount val="1"/>
                <c:pt idx="0">
                  <c:v>child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WS_AC!$BB$23:$BF$23</c:f>
                <c:numCache>
                  <c:formatCode>General</c:formatCode>
                  <c:ptCount val="5"/>
                  <c:pt idx="0">
                    <c:v>0.2378265</c:v>
                  </c:pt>
                  <c:pt idx="1">
                    <c:v>0.22837440000000001</c:v>
                  </c:pt>
                  <c:pt idx="2">
                    <c:v>0.18646750000000001</c:v>
                  </c:pt>
                  <c:pt idx="3">
                    <c:v>0.2057204</c:v>
                  </c:pt>
                  <c:pt idx="4">
                    <c:v>0.2241987</c:v>
                  </c:pt>
                </c:numCache>
              </c:numRef>
            </c:plus>
            <c:minus>
              <c:numRef>
                <c:f>WS_AC!$BB$23:$BF$23</c:f>
                <c:numCache>
                  <c:formatCode>General</c:formatCode>
                  <c:ptCount val="5"/>
                  <c:pt idx="0">
                    <c:v>0.2378265</c:v>
                  </c:pt>
                  <c:pt idx="1">
                    <c:v>0.22837440000000001</c:v>
                  </c:pt>
                  <c:pt idx="2">
                    <c:v>0.18646750000000001</c:v>
                  </c:pt>
                  <c:pt idx="3">
                    <c:v>0.2057204</c:v>
                  </c:pt>
                  <c:pt idx="4">
                    <c:v>0.22419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WS_AC!$BB$20:$BF$20</c:f>
              <c:strCache>
                <c:ptCount val="5"/>
                <c:pt idx="0">
                  <c:v>x-2</c:v>
                </c:pt>
                <c:pt idx="1">
                  <c:v>x-1</c:v>
                </c:pt>
                <c:pt idx="2">
                  <c:v>x</c:v>
                </c:pt>
                <c:pt idx="3">
                  <c:v>x+1</c:v>
                </c:pt>
                <c:pt idx="4">
                  <c:v>x+2</c:v>
                </c:pt>
              </c:strCache>
            </c:strRef>
          </c:cat>
          <c:val>
            <c:numRef>
              <c:f>WS_AC!$BB$21:$BF$21</c:f>
              <c:numCache>
                <c:formatCode>General</c:formatCode>
                <c:ptCount val="5"/>
                <c:pt idx="0">
                  <c:v>0.46266099999999999</c:v>
                </c:pt>
                <c:pt idx="1">
                  <c:v>0.432002</c:v>
                </c:pt>
                <c:pt idx="2">
                  <c:v>0.36388799999999999</c:v>
                </c:pt>
                <c:pt idx="3">
                  <c:v>0.42491000000000001</c:v>
                </c:pt>
                <c:pt idx="4">
                  <c:v>0.472536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36-43C8-BAC2-1949B64F9409}"/>
            </c:ext>
          </c:extLst>
        </c:ser>
        <c:ser>
          <c:idx val="1"/>
          <c:order val="1"/>
          <c:tx>
            <c:strRef>
              <c:f>WS_AC!$BA$22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WS_AC!$BB$24:$BF$24</c:f>
                <c:numCache>
                  <c:formatCode>General</c:formatCode>
                  <c:ptCount val="5"/>
                  <c:pt idx="0">
                    <c:v>0.19826269999999999</c:v>
                  </c:pt>
                  <c:pt idx="1">
                    <c:v>0.18577250000000001</c:v>
                  </c:pt>
                  <c:pt idx="2">
                    <c:v>9.3089000000000005E-2</c:v>
                  </c:pt>
                  <c:pt idx="3">
                    <c:v>0.21445900000000001</c:v>
                  </c:pt>
                  <c:pt idx="4">
                    <c:v>0.2452754</c:v>
                  </c:pt>
                </c:numCache>
              </c:numRef>
            </c:plus>
            <c:minus>
              <c:numRef>
                <c:f>WS_AC!$BB$24:$BF$24</c:f>
                <c:numCache>
                  <c:formatCode>General</c:formatCode>
                  <c:ptCount val="5"/>
                  <c:pt idx="0">
                    <c:v>0.19826269999999999</c:v>
                  </c:pt>
                  <c:pt idx="1">
                    <c:v>0.18577250000000001</c:v>
                  </c:pt>
                  <c:pt idx="2">
                    <c:v>9.3089000000000005E-2</c:v>
                  </c:pt>
                  <c:pt idx="3">
                    <c:v>0.21445900000000001</c:v>
                  </c:pt>
                  <c:pt idx="4">
                    <c:v>0.24527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WS_AC!$BB$20:$BF$20</c:f>
              <c:strCache>
                <c:ptCount val="5"/>
                <c:pt idx="0">
                  <c:v>x-2</c:v>
                </c:pt>
                <c:pt idx="1">
                  <c:v>x-1</c:v>
                </c:pt>
                <c:pt idx="2">
                  <c:v>x</c:v>
                </c:pt>
                <c:pt idx="3">
                  <c:v>x+1</c:v>
                </c:pt>
                <c:pt idx="4">
                  <c:v>x+2</c:v>
                </c:pt>
              </c:strCache>
            </c:strRef>
          </c:cat>
          <c:val>
            <c:numRef>
              <c:f>WS_AC!$BB$22:$BF$22</c:f>
              <c:numCache>
                <c:formatCode>General</c:formatCode>
                <c:ptCount val="5"/>
                <c:pt idx="0">
                  <c:v>0.28247499999999998</c:v>
                </c:pt>
                <c:pt idx="1">
                  <c:v>0.25316300000000003</c:v>
                </c:pt>
                <c:pt idx="2">
                  <c:v>0.15971199999999999</c:v>
                </c:pt>
                <c:pt idx="3">
                  <c:v>0.25029000000000001</c:v>
                </c:pt>
                <c:pt idx="4">
                  <c:v>0.289617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C36-43C8-BAC2-1949B64F94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18854064"/>
        <c:axId val="1018854480"/>
      </c:barChart>
      <c:catAx>
        <c:axId val="1018854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18854480"/>
        <c:crosses val="autoZero"/>
        <c:auto val="1"/>
        <c:lblAlgn val="ctr"/>
        <c:lblOffset val="100"/>
        <c:noMultiLvlLbl val="0"/>
      </c:catAx>
      <c:valAx>
        <c:axId val="1018854480"/>
        <c:scaling>
          <c:orientation val="minMax"/>
          <c:max val="6"/>
          <c:min val="-0.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18854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7997684659441"/>
          <c:y val="2.8388075966963196E-2"/>
          <c:w val="0.82693867592110715"/>
          <c:h val="0.893334854046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WS_AC!$BA$21</c:f>
              <c:strCache>
                <c:ptCount val="1"/>
                <c:pt idx="0">
                  <c:v>child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WS_AC!$BI$23:$BM$23</c:f>
                <c:numCache>
                  <c:formatCode>General</c:formatCode>
                  <c:ptCount val="5"/>
                  <c:pt idx="0">
                    <c:v>0.39219369999999998</c:v>
                  </c:pt>
                  <c:pt idx="1">
                    <c:v>0.33066069999999997</c:v>
                  </c:pt>
                  <c:pt idx="2">
                    <c:v>0.32932220000000001</c:v>
                  </c:pt>
                  <c:pt idx="3">
                    <c:v>0.43666339999999998</c:v>
                  </c:pt>
                  <c:pt idx="4">
                    <c:v>0.53796520000000003</c:v>
                  </c:pt>
                </c:numCache>
              </c:numRef>
            </c:plus>
            <c:minus>
              <c:numRef>
                <c:f>WS_AC!$BI$23:$BM$23</c:f>
                <c:numCache>
                  <c:formatCode>General</c:formatCode>
                  <c:ptCount val="5"/>
                  <c:pt idx="0">
                    <c:v>0.39219369999999998</c:v>
                  </c:pt>
                  <c:pt idx="1">
                    <c:v>0.33066069999999997</c:v>
                  </c:pt>
                  <c:pt idx="2">
                    <c:v>0.32932220000000001</c:v>
                  </c:pt>
                  <c:pt idx="3">
                    <c:v>0.43666339999999998</c:v>
                  </c:pt>
                  <c:pt idx="4">
                    <c:v>0.537965200000000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WS_AC!$BI$20:$BM$20</c:f>
              <c:strCache>
                <c:ptCount val="5"/>
                <c:pt idx="0">
                  <c:v>x-2</c:v>
                </c:pt>
                <c:pt idx="1">
                  <c:v>x-1</c:v>
                </c:pt>
                <c:pt idx="2">
                  <c:v>x</c:v>
                </c:pt>
                <c:pt idx="3">
                  <c:v>x+1</c:v>
                </c:pt>
                <c:pt idx="4">
                  <c:v>x+2</c:v>
                </c:pt>
              </c:strCache>
            </c:strRef>
          </c:cat>
          <c:val>
            <c:numRef>
              <c:f>WS_AC!$BI$21:$BM$21</c:f>
              <c:numCache>
                <c:formatCode>General</c:formatCode>
                <c:ptCount val="5"/>
                <c:pt idx="0">
                  <c:v>0.56178499999999998</c:v>
                </c:pt>
                <c:pt idx="1">
                  <c:v>0.468391</c:v>
                </c:pt>
                <c:pt idx="2">
                  <c:v>0.46342699999999998</c:v>
                </c:pt>
                <c:pt idx="3">
                  <c:v>0.64216700000000004</c:v>
                </c:pt>
                <c:pt idx="4">
                  <c:v>0.7020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70-4D57-B500-0B8379000A37}"/>
            </c:ext>
          </c:extLst>
        </c:ser>
        <c:ser>
          <c:idx val="1"/>
          <c:order val="1"/>
          <c:tx>
            <c:strRef>
              <c:f>WS_AC!$BA$22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WS_AC!$BI$24:$BM$24</c:f>
                <c:numCache>
                  <c:formatCode>General</c:formatCode>
                  <c:ptCount val="5"/>
                  <c:pt idx="0">
                    <c:v>0.48588399999999998</c:v>
                  </c:pt>
                  <c:pt idx="1">
                    <c:v>0.4252611</c:v>
                  </c:pt>
                  <c:pt idx="2">
                    <c:v>0.44912229999999997</c:v>
                  </c:pt>
                  <c:pt idx="3">
                    <c:v>0.50386799999999998</c:v>
                  </c:pt>
                  <c:pt idx="4">
                    <c:v>0.401669</c:v>
                  </c:pt>
                </c:numCache>
              </c:numRef>
            </c:plus>
            <c:minus>
              <c:numRef>
                <c:f>WS_AC!$BI$24:$BM$24</c:f>
                <c:numCache>
                  <c:formatCode>General</c:formatCode>
                  <c:ptCount val="5"/>
                  <c:pt idx="0">
                    <c:v>0.48588399999999998</c:v>
                  </c:pt>
                  <c:pt idx="1">
                    <c:v>0.4252611</c:v>
                  </c:pt>
                  <c:pt idx="2">
                    <c:v>0.44912229999999997</c:v>
                  </c:pt>
                  <c:pt idx="3">
                    <c:v>0.50386799999999998</c:v>
                  </c:pt>
                  <c:pt idx="4">
                    <c:v>0.4016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WS_AC!$BI$20:$BM$20</c:f>
              <c:strCache>
                <c:ptCount val="5"/>
                <c:pt idx="0">
                  <c:v>x-2</c:v>
                </c:pt>
                <c:pt idx="1">
                  <c:v>x-1</c:v>
                </c:pt>
                <c:pt idx="2">
                  <c:v>x</c:v>
                </c:pt>
                <c:pt idx="3">
                  <c:v>x+1</c:v>
                </c:pt>
                <c:pt idx="4">
                  <c:v>x+2</c:v>
                </c:pt>
              </c:strCache>
            </c:strRef>
          </c:cat>
          <c:val>
            <c:numRef>
              <c:f>WS_AC!$BI$22:$BM$22</c:f>
              <c:numCache>
                <c:formatCode>General</c:formatCode>
                <c:ptCount val="5"/>
                <c:pt idx="0">
                  <c:v>0.31642999999999999</c:v>
                </c:pt>
                <c:pt idx="1">
                  <c:v>0.259382</c:v>
                </c:pt>
                <c:pt idx="2">
                  <c:v>0.28634999999999999</c:v>
                </c:pt>
                <c:pt idx="3">
                  <c:v>0.38846700000000001</c:v>
                </c:pt>
                <c:pt idx="4">
                  <c:v>0.3544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370-4D57-B500-0B8379000A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18854064"/>
        <c:axId val="1018854480"/>
      </c:barChart>
      <c:catAx>
        <c:axId val="1018854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18854480"/>
        <c:crosses val="autoZero"/>
        <c:auto val="1"/>
        <c:lblAlgn val="ctr"/>
        <c:lblOffset val="100"/>
        <c:noMultiLvlLbl val="0"/>
      </c:catAx>
      <c:valAx>
        <c:axId val="1018854480"/>
        <c:scaling>
          <c:orientation val="minMax"/>
          <c:max val="6"/>
          <c:min val="-0.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18854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100337048174399"/>
          <c:y val="2.5597427203907536E-2"/>
          <c:w val="0.83273507390530721"/>
          <c:h val="0.918639038162671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WS_AC!$BA$4</c:f>
              <c:strCache>
                <c:ptCount val="1"/>
                <c:pt idx="0">
                  <c:v>child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WS_AC!$BB$6:$BF$6</c:f>
                <c:numCache>
                  <c:formatCode>General</c:formatCode>
                  <c:ptCount val="5"/>
                  <c:pt idx="0">
                    <c:v>1.6957414</c:v>
                  </c:pt>
                  <c:pt idx="1">
                    <c:v>1.7645518</c:v>
                  </c:pt>
                  <c:pt idx="2">
                    <c:v>2.0396618000000002</c:v>
                  </c:pt>
                  <c:pt idx="3">
                    <c:v>1.6919736999999999</c:v>
                  </c:pt>
                  <c:pt idx="4">
                    <c:v>1.5581403</c:v>
                  </c:pt>
                </c:numCache>
              </c:numRef>
            </c:plus>
            <c:minus>
              <c:numRef>
                <c:f>WS_AC!$BB$6:$BF$6</c:f>
                <c:numCache>
                  <c:formatCode>General</c:formatCode>
                  <c:ptCount val="5"/>
                  <c:pt idx="0">
                    <c:v>1.6957414</c:v>
                  </c:pt>
                  <c:pt idx="1">
                    <c:v>1.7645518</c:v>
                  </c:pt>
                  <c:pt idx="2">
                    <c:v>2.0396618000000002</c:v>
                  </c:pt>
                  <c:pt idx="3">
                    <c:v>1.6919736999999999</c:v>
                  </c:pt>
                  <c:pt idx="4">
                    <c:v>1.55814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WS_AC!$BB$3:$BF$3</c:f>
              <c:strCache>
                <c:ptCount val="5"/>
                <c:pt idx="0">
                  <c:v>x-2</c:v>
                </c:pt>
                <c:pt idx="1">
                  <c:v>x-1</c:v>
                </c:pt>
                <c:pt idx="2">
                  <c:v>x</c:v>
                </c:pt>
                <c:pt idx="3">
                  <c:v>x+1</c:v>
                </c:pt>
                <c:pt idx="4">
                  <c:v>x+2</c:v>
                </c:pt>
              </c:strCache>
            </c:strRef>
          </c:cat>
          <c:val>
            <c:numRef>
              <c:f>WS_AC!$BB$4:$BF$4</c:f>
              <c:numCache>
                <c:formatCode>General</c:formatCode>
                <c:ptCount val="5"/>
                <c:pt idx="0">
                  <c:v>2.5398909999999999</c:v>
                </c:pt>
                <c:pt idx="1">
                  <c:v>2.8004560000000001</c:v>
                </c:pt>
                <c:pt idx="2">
                  <c:v>3.4272469999999999</c:v>
                </c:pt>
                <c:pt idx="3">
                  <c:v>2.4246539999999999</c:v>
                </c:pt>
                <c:pt idx="4">
                  <c:v>1.818197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3A-4215-A7FB-BABA45B967A3}"/>
            </c:ext>
          </c:extLst>
        </c:ser>
        <c:ser>
          <c:idx val="1"/>
          <c:order val="1"/>
          <c:tx>
            <c:strRef>
              <c:f>WS_AC!$BA$5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WS_AC!$BB$7:$BF$7</c:f>
                <c:numCache>
                  <c:formatCode>General</c:formatCode>
                  <c:ptCount val="5"/>
                  <c:pt idx="0">
                    <c:v>0.67944550000000004</c:v>
                  </c:pt>
                  <c:pt idx="1">
                    <c:v>0.64279889999999995</c:v>
                  </c:pt>
                  <c:pt idx="2">
                    <c:v>0.82419469999999995</c:v>
                  </c:pt>
                  <c:pt idx="3">
                    <c:v>0.34603139999999999</c:v>
                  </c:pt>
                  <c:pt idx="4">
                    <c:v>0.47114899999999998</c:v>
                  </c:pt>
                </c:numCache>
              </c:numRef>
            </c:plus>
            <c:minus>
              <c:numRef>
                <c:f>WS_AC!$BB$7:$BF$7</c:f>
                <c:numCache>
                  <c:formatCode>General</c:formatCode>
                  <c:ptCount val="5"/>
                  <c:pt idx="0">
                    <c:v>0.67944550000000004</c:v>
                  </c:pt>
                  <c:pt idx="1">
                    <c:v>0.64279889999999995</c:v>
                  </c:pt>
                  <c:pt idx="2">
                    <c:v>0.82419469999999995</c:v>
                  </c:pt>
                  <c:pt idx="3">
                    <c:v>0.34603139999999999</c:v>
                  </c:pt>
                  <c:pt idx="4">
                    <c:v>0.471148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WS_AC!$BB$3:$BF$3</c:f>
              <c:strCache>
                <c:ptCount val="5"/>
                <c:pt idx="0">
                  <c:v>x-2</c:v>
                </c:pt>
                <c:pt idx="1">
                  <c:v>x-1</c:v>
                </c:pt>
                <c:pt idx="2">
                  <c:v>x</c:v>
                </c:pt>
                <c:pt idx="3">
                  <c:v>x+1</c:v>
                </c:pt>
                <c:pt idx="4">
                  <c:v>x+2</c:v>
                </c:pt>
              </c:strCache>
            </c:strRef>
          </c:cat>
          <c:val>
            <c:numRef>
              <c:f>WS_AC!$BB$5:$BF$5</c:f>
              <c:numCache>
                <c:formatCode>General</c:formatCode>
                <c:ptCount val="5"/>
                <c:pt idx="0">
                  <c:v>1.2419610000000001</c:v>
                </c:pt>
                <c:pt idx="1">
                  <c:v>1.2473339999999999</c:v>
                </c:pt>
                <c:pt idx="2">
                  <c:v>1.5136270000000001</c:v>
                </c:pt>
                <c:pt idx="3">
                  <c:v>0.94177500000000003</c:v>
                </c:pt>
                <c:pt idx="4">
                  <c:v>0.744705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13A-4215-A7FB-BABA45B967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18854064"/>
        <c:axId val="1018854480"/>
      </c:barChart>
      <c:catAx>
        <c:axId val="1018854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18854480"/>
        <c:crosses val="autoZero"/>
        <c:auto val="1"/>
        <c:lblAlgn val="ctr"/>
        <c:lblOffset val="100"/>
        <c:noMultiLvlLbl val="0"/>
      </c:catAx>
      <c:valAx>
        <c:axId val="1018854480"/>
        <c:scaling>
          <c:orientation val="minMax"/>
          <c:min val="-0.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188540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2466123219205905"/>
          <c:y val="5.8967234989733858E-2"/>
          <c:w val="0.32426941531161707"/>
          <c:h val="7.061612700957185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2667A28-18A6-584C-BC27-E4FCAF2577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D8499B0-A926-6D44-9876-43242F5864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B91EB2E-CE4E-674B-B2BA-2173CBA87D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1239F-47F1-4942-9CF7-9A1BF1421071}" type="datetimeFigureOut">
              <a:rPr kumimoji="1" lang="ja-JP" altLang="en-US" smtClean="0"/>
              <a:t>2022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E68A0D7-2506-C947-9CDB-E0475EFEC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2AEDC2F-8F70-4449-BF09-9A2BABD4E4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C9D78-C646-5247-BF69-E11CD0E6CB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0309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113AB8F-98D2-6345-AE6D-5ED6EC0559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1D7FFF2-C7D9-7A45-969C-61B2983D54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AAE4AC-E772-6F4F-B51C-EFB65F9EC1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1239F-47F1-4942-9CF7-9A1BF1421071}" type="datetimeFigureOut">
              <a:rPr kumimoji="1" lang="ja-JP" altLang="en-US" smtClean="0"/>
              <a:t>2022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59B80DD-8262-3040-AE70-34A2955DA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3CDB948-498C-1542-9E9D-914006FFC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C9D78-C646-5247-BF69-E11CD0E6CB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22112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DFE8379-CC8A-6445-8106-35AFCFA798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9F19AD2-723F-EB48-9A78-18D6965B70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F90FFD-3C4F-F343-B236-31C7489A1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1239F-47F1-4942-9CF7-9A1BF1421071}" type="datetimeFigureOut">
              <a:rPr kumimoji="1" lang="ja-JP" altLang="en-US" smtClean="0"/>
              <a:t>2022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6495BA4-97C1-584C-BE97-693319C2D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A464AF7-9A21-3147-8677-4BAA93564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C9D78-C646-5247-BF69-E11CD0E6CB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3499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E4E665-D7E9-C449-87D6-8125F2030D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E65C239-DEAF-AE4F-A9A2-E4E9FBC493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27CFD1D-FD97-D140-AA72-999C2A1CB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1239F-47F1-4942-9CF7-9A1BF1421071}" type="datetimeFigureOut">
              <a:rPr kumimoji="1" lang="ja-JP" altLang="en-US" smtClean="0"/>
              <a:t>2022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D7B4F7-0242-AA46-AB7D-8D2648A682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83DC20F-EA72-2D40-AB61-9F888BBFB3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C9D78-C646-5247-BF69-E11CD0E6CB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3281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29459C-866D-894D-89D1-8130C2293B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C7C9B37-A00A-4343-8746-02BCAD6E9B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666331-6B3A-B145-9A48-E94DE4FAC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1239F-47F1-4942-9CF7-9A1BF1421071}" type="datetimeFigureOut">
              <a:rPr kumimoji="1" lang="ja-JP" altLang="en-US" smtClean="0"/>
              <a:t>2022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DCAF42-321C-0448-A018-BCEBD01028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AB0F39-54F2-9D47-A613-71DEE8D0E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C9D78-C646-5247-BF69-E11CD0E6CB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7004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D2F591-B8F7-4947-B06B-BE5901E2A8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538D46E-541C-A741-A63B-25E2B9EB35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8537171-BC93-C343-AA56-6A71D79D27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53D1675-78B6-A442-ACC0-0C74385D4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1239F-47F1-4942-9CF7-9A1BF1421071}" type="datetimeFigureOut">
              <a:rPr kumimoji="1" lang="ja-JP" altLang="en-US" smtClean="0"/>
              <a:t>2022/4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64D1E06-0A99-9B4F-9FAB-8A2AF00BE9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AB72FAB-C850-104D-926B-88C15ACFB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C9D78-C646-5247-BF69-E11CD0E6CB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4902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2C31E9-C112-0540-A254-A270E921B4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4EF1FD9-194D-5C4E-BD45-C652522FC2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9F1ED7D-2211-E54B-97E0-B0E8CE4BB4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7239670-16B1-6E4B-A77D-204AA199CE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1C05F38-AFAC-7245-A528-DE8C4E50B1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621E875-395D-1A4F-A1BE-1121D37428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1239F-47F1-4942-9CF7-9A1BF1421071}" type="datetimeFigureOut">
              <a:rPr kumimoji="1" lang="ja-JP" altLang="en-US" smtClean="0"/>
              <a:t>2022/4/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46D47BD-7904-5349-A9EE-1E9D64FE4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5707E69-4C57-6E4A-B857-329890ACB3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C9D78-C646-5247-BF69-E11CD0E6CB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57565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BBA91D-82C1-3045-A979-1A0C658AFD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D8410FF-5769-FB42-B765-475D42B04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1239F-47F1-4942-9CF7-9A1BF1421071}" type="datetimeFigureOut">
              <a:rPr kumimoji="1" lang="ja-JP" altLang="en-US" smtClean="0"/>
              <a:t>2022/4/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63D5A5E-0CA2-7946-9294-A1531D4E90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37CA81D-DD15-D44D-A3E8-38B644B400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C9D78-C646-5247-BF69-E11CD0E6CB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0479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8400334-19E1-8C46-B6FC-382E3D64F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1239F-47F1-4942-9CF7-9A1BF1421071}" type="datetimeFigureOut">
              <a:rPr kumimoji="1" lang="ja-JP" altLang="en-US" smtClean="0"/>
              <a:t>2022/4/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0419A52-9B7A-4544-A563-AF6BD04B2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EAF66D8-4D7A-CA49-837D-E52E11DC1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C9D78-C646-5247-BF69-E11CD0E6CB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1938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EA4139-81F7-6B4A-981C-2E12F632F8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5C513D2-4703-9644-9938-E07AB4BBA7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A271764-EC19-724C-85A0-75F5B2CA34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14C2710-24EF-9046-B772-A2ED53753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1239F-47F1-4942-9CF7-9A1BF1421071}" type="datetimeFigureOut">
              <a:rPr kumimoji="1" lang="ja-JP" altLang="en-US" smtClean="0"/>
              <a:t>2022/4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B91E0D2-6EC7-D046-9C01-AF67795D6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962EE4B-2204-7B48-8E3D-64E6A4946F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C9D78-C646-5247-BF69-E11CD0E6CB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2039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99031C-72F2-DA45-A1AC-477417DA1A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7D761A0-3B01-2749-A029-C0F135DC1D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6F567C3-2F2F-874A-8F9A-0F6F08798E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4E9C8F8-74F6-594A-BBCC-3DD44F6AD9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1239F-47F1-4942-9CF7-9A1BF1421071}" type="datetimeFigureOut">
              <a:rPr kumimoji="1" lang="ja-JP" altLang="en-US" smtClean="0"/>
              <a:t>2022/4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75ED993-459C-EF41-9B40-B8B438E3F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C1AF94A-5405-2947-A925-6BEE00B83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C9D78-C646-5247-BF69-E11CD0E6CB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012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7DA79E0-DFAF-A74C-91E1-1D6B45C403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D827ABD-1E0F-764A-868A-80920BE7AF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08916D1-ABF5-7044-B9FC-1C777D3AB0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1239F-47F1-4942-9CF7-9A1BF1421071}" type="datetimeFigureOut">
              <a:rPr kumimoji="1" lang="ja-JP" altLang="en-US" smtClean="0"/>
              <a:t>2022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E91F70F-2322-F04E-906B-152CD98555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66AFE1D-2DB0-4344-80D9-333BCDC6B6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C9D78-C646-5247-BF69-E11CD0E6CB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8628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F224067A-C2CC-4EAC-A6A0-1F7358A057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700102"/>
              </p:ext>
            </p:extLst>
          </p:nvPr>
        </p:nvGraphicFramePr>
        <p:xfrm>
          <a:off x="4427808" y="314690"/>
          <a:ext cx="3852565" cy="38227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2AE122CA-F36F-4C5F-B74D-B18456CEB2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1958869"/>
              </p:ext>
            </p:extLst>
          </p:nvPr>
        </p:nvGraphicFramePr>
        <p:xfrm>
          <a:off x="8405729" y="285581"/>
          <a:ext cx="3852565" cy="38227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0242DA69-E83C-49B9-B0C6-05BE868210F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9895678"/>
              </p:ext>
            </p:extLst>
          </p:nvPr>
        </p:nvGraphicFramePr>
        <p:xfrm>
          <a:off x="484484" y="275070"/>
          <a:ext cx="3852565" cy="38227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6699C14-C40C-4F99-9F4C-7773CF9AC093}"/>
              </a:ext>
            </a:extLst>
          </p:cNvPr>
          <p:cNvSpPr txBox="1"/>
          <p:nvPr/>
        </p:nvSpPr>
        <p:spPr>
          <a:xfrm>
            <a:off x="5038287" y="329406"/>
            <a:ext cx="934871" cy="30777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400" dirty="0"/>
              <a:t>B. NREM</a:t>
            </a:r>
            <a:endParaRPr kumimoji="1" lang="ja-JP" altLang="en-US" sz="14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BBA5659-F68E-4F8E-862E-6DAC5A12EA76}"/>
              </a:ext>
            </a:extLst>
          </p:cNvPr>
          <p:cNvSpPr txBox="1"/>
          <p:nvPr/>
        </p:nvSpPr>
        <p:spPr>
          <a:xfrm>
            <a:off x="9077548" y="394593"/>
            <a:ext cx="800219" cy="30777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400" dirty="0"/>
              <a:t>C. REM</a:t>
            </a:r>
            <a:endParaRPr kumimoji="1" lang="ja-JP" altLang="en-US" sz="14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42DA7E0-34F2-457A-AEBE-F827A43B50CE}"/>
              </a:ext>
            </a:extLst>
          </p:cNvPr>
          <p:cNvSpPr txBox="1"/>
          <p:nvPr/>
        </p:nvSpPr>
        <p:spPr>
          <a:xfrm>
            <a:off x="1016454" y="296091"/>
            <a:ext cx="862737" cy="30777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1400" dirty="0"/>
              <a:t>A. Wake</a:t>
            </a:r>
          </a:p>
        </p:txBody>
      </p:sp>
      <p:graphicFrame>
        <p:nvGraphicFramePr>
          <p:cNvPr id="11" name="表 4">
            <a:extLst>
              <a:ext uri="{FF2B5EF4-FFF2-40B4-BE49-F238E27FC236}">
                <a16:creationId xmlns:a16="http://schemas.microsoft.com/office/drawing/2014/main" id="{D8976646-A878-471C-A270-58E30C1B90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37327426"/>
              </p:ext>
            </p:extLst>
          </p:nvPr>
        </p:nvGraphicFramePr>
        <p:xfrm>
          <a:off x="828291" y="4658214"/>
          <a:ext cx="2951747" cy="127710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375195">
                  <a:extLst>
                    <a:ext uri="{9D8B030D-6E8A-4147-A177-3AD203B41FA5}">
                      <a16:colId xmlns:a16="http://schemas.microsoft.com/office/drawing/2014/main" val="3666749762"/>
                    </a:ext>
                  </a:extLst>
                </a:gridCol>
                <a:gridCol w="714704">
                  <a:extLst>
                    <a:ext uri="{9D8B030D-6E8A-4147-A177-3AD203B41FA5}">
                      <a16:colId xmlns:a16="http://schemas.microsoft.com/office/drawing/2014/main" val="3087899733"/>
                    </a:ext>
                  </a:extLst>
                </a:gridCol>
                <a:gridCol w="861848">
                  <a:extLst>
                    <a:ext uri="{9D8B030D-6E8A-4147-A177-3AD203B41FA5}">
                      <a16:colId xmlns:a16="http://schemas.microsoft.com/office/drawing/2014/main" val="1823426826"/>
                    </a:ext>
                  </a:extLst>
                </a:gridCol>
              </a:tblGrid>
              <a:tr h="268131"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(Wake)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0" i="1" dirty="0"/>
                        <a:t>F</a:t>
                      </a:r>
                      <a:endParaRPr kumimoji="1" lang="ja-JP" altLang="en-US" sz="1400" b="0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0" i="1" dirty="0"/>
                        <a:t>P</a:t>
                      </a:r>
                      <a:endParaRPr kumimoji="1" lang="ja-JP" altLang="en-US" sz="1400" b="0" i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87389868"/>
                  </a:ext>
                </a:extLst>
              </a:tr>
              <a:tr h="195002"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group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11.43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001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6888440"/>
                  </a:ext>
                </a:extLst>
              </a:tr>
              <a:tr h="268131"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epoch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15.00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&lt;0.0001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9396903"/>
                  </a:ext>
                </a:extLst>
              </a:tr>
              <a:tr h="362700">
                <a:tc>
                  <a:txBody>
                    <a:bodyPr/>
                    <a:lstStyle/>
                    <a:p>
                      <a:r>
                        <a:rPr kumimoji="1" lang="en-US" altLang="ja-JP" sz="1400" dirty="0" err="1"/>
                        <a:t>groupXepoch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1.91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 err="1"/>
                        <a:t>n.s</a:t>
                      </a:r>
                      <a:r>
                        <a:rPr kumimoji="1" lang="en-US" altLang="ja-JP" sz="1400" dirty="0"/>
                        <a:t>.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3171706"/>
                  </a:ext>
                </a:extLst>
              </a:tr>
            </a:tbl>
          </a:graphicData>
        </a:graphic>
      </p:graphicFrame>
      <p:graphicFrame>
        <p:nvGraphicFramePr>
          <p:cNvPr id="12" name="表 4">
            <a:extLst>
              <a:ext uri="{FF2B5EF4-FFF2-40B4-BE49-F238E27FC236}">
                <a16:creationId xmlns:a16="http://schemas.microsoft.com/office/drawing/2014/main" id="{A37435BC-FCE8-4DD4-89E2-B73926A926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7833655"/>
              </p:ext>
            </p:extLst>
          </p:nvPr>
        </p:nvGraphicFramePr>
        <p:xfrm>
          <a:off x="5156657" y="4624995"/>
          <a:ext cx="2956159" cy="127710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379607">
                  <a:extLst>
                    <a:ext uri="{9D8B030D-6E8A-4147-A177-3AD203B41FA5}">
                      <a16:colId xmlns:a16="http://schemas.microsoft.com/office/drawing/2014/main" val="3666749762"/>
                    </a:ext>
                  </a:extLst>
                </a:gridCol>
                <a:gridCol w="704193">
                  <a:extLst>
                    <a:ext uri="{9D8B030D-6E8A-4147-A177-3AD203B41FA5}">
                      <a16:colId xmlns:a16="http://schemas.microsoft.com/office/drawing/2014/main" val="3381792953"/>
                    </a:ext>
                  </a:extLst>
                </a:gridCol>
                <a:gridCol w="872359">
                  <a:extLst>
                    <a:ext uri="{9D8B030D-6E8A-4147-A177-3AD203B41FA5}">
                      <a16:colId xmlns:a16="http://schemas.microsoft.com/office/drawing/2014/main" val="3619158226"/>
                    </a:ext>
                  </a:extLst>
                </a:gridCol>
              </a:tblGrid>
              <a:tr h="268131"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(NREM)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0" i="1" dirty="0"/>
                        <a:t>F</a:t>
                      </a:r>
                      <a:endParaRPr kumimoji="1" lang="ja-JP" altLang="en-US" sz="1400" b="0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0" i="1" dirty="0"/>
                        <a:t>P</a:t>
                      </a:r>
                      <a:endParaRPr kumimoji="1" lang="ja-JP" altLang="en-US" sz="1400" b="0" i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87389868"/>
                  </a:ext>
                </a:extLst>
              </a:tr>
              <a:tr h="195002"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group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/>
                        <a:t>9.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003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6888440"/>
                  </a:ext>
                </a:extLst>
              </a:tr>
              <a:tr h="268131"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epoch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/>
                        <a:t>25.18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/>
                        <a:t>&lt;0.0001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9396903"/>
                  </a:ext>
                </a:extLst>
              </a:tr>
              <a:tr h="362700">
                <a:tc>
                  <a:txBody>
                    <a:bodyPr/>
                    <a:lstStyle/>
                    <a:p>
                      <a:r>
                        <a:rPr kumimoji="1" lang="en-US" altLang="ja-JP" sz="1400" dirty="0" err="1"/>
                        <a:t>groupXepoch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381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 err="1"/>
                        <a:t>n.s</a:t>
                      </a:r>
                      <a:r>
                        <a:rPr kumimoji="1" lang="en-US" altLang="ja-JP" sz="1400" dirty="0"/>
                        <a:t>.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3171706"/>
                  </a:ext>
                </a:extLst>
              </a:tr>
            </a:tbl>
          </a:graphicData>
        </a:graphic>
      </p:graphicFrame>
      <p:graphicFrame>
        <p:nvGraphicFramePr>
          <p:cNvPr id="13" name="表 4">
            <a:extLst>
              <a:ext uri="{FF2B5EF4-FFF2-40B4-BE49-F238E27FC236}">
                <a16:creationId xmlns:a16="http://schemas.microsoft.com/office/drawing/2014/main" id="{0A9891B6-462D-4FFE-82C8-7D2F1CEA55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0707064"/>
              </p:ext>
            </p:extLst>
          </p:nvPr>
        </p:nvGraphicFramePr>
        <p:xfrm>
          <a:off x="9025636" y="4658214"/>
          <a:ext cx="3000795" cy="127710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375195">
                  <a:extLst>
                    <a:ext uri="{9D8B030D-6E8A-4147-A177-3AD203B41FA5}">
                      <a16:colId xmlns:a16="http://schemas.microsoft.com/office/drawing/2014/main" val="3666749762"/>
                    </a:ext>
                  </a:extLst>
                </a:gridCol>
                <a:gridCol w="812800">
                  <a:extLst>
                    <a:ext uri="{9D8B030D-6E8A-4147-A177-3AD203B41FA5}">
                      <a16:colId xmlns:a16="http://schemas.microsoft.com/office/drawing/2014/main" val="10551108"/>
                    </a:ext>
                  </a:extLst>
                </a:gridCol>
                <a:gridCol w="812800">
                  <a:extLst>
                    <a:ext uri="{9D8B030D-6E8A-4147-A177-3AD203B41FA5}">
                      <a16:colId xmlns:a16="http://schemas.microsoft.com/office/drawing/2014/main" val="3978986717"/>
                    </a:ext>
                  </a:extLst>
                </a:gridCol>
              </a:tblGrid>
              <a:tr h="268131"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(REM)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0" i="1" dirty="0"/>
                        <a:t>F</a:t>
                      </a:r>
                      <a:endParaRPr kumimoji="1" lang="ja-JP" altLang="en-US" sz="1400" b="0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0" i="1" dirty="0"/>
                        <a:t>P</a:t>
                      </a:r>
                      <a:endParaRPr kumimoji="1" lang="ja-JP" altLang="en-US" sz="1400" b="0" i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87389868"/>
                  </a:ext>
                </a:extLst>
              </a:tr>
              <a:tr h="195002"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group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4.75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033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6888440"/>
                  </a:ext>
                </a:extLst>
              </a:tr>
              <a:tr h="268131"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epoch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7.02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002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9396903"/>
                  </a:ext>
                </a:extLst>
              </a:tr>
              <a:tr h="362700">
                <a:tc>
                  <a:txBody>
                    <a:bodyPr/>
                    <a:lstStyle/>
                    <a:p>
                      <a:r>
                        <a:rPr kumimoji="1" lang="en-US" altLang="ja-JP" sz="1400" dirty="0" err="1"/>
                        <a:t>groupXepoch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24</a:t>
                      </a:r>
                      <a:endParaRPr kumimoji="1" lang="ja-JP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 err="1"/>
                        <a:t>n.s</a:t>
                      </a:r>
                      <a:r>
                        <a:rPr kumimoji="1" lang="en-US" altLang="ja-JP" sz="1400" dirty="0"/>
                        <a:t>.</a:t>
                      </a:r>
                      <a:endParaRPr kumimoji="1" lang="ja-JP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3171706"/>
                  </a:ext>
                </a:extLst>
              </a:tr>
            </a:tbl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6D81078-65FC-470C-9366-245B50CD41B6}"/>
              </a:ext>
            </a:extLst>
          </p:cNvPr>
          <p:cNvSpPr txBox="1"/>
          <p:nvPr/>
        </p:nvSpPr>
        <p:spPr>
          <a:xfrm>
            <a:off x="484484" y="6311025"/>
            <a:ext cx="60967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S</a:t>
            </a:r>
            <a:r>
              <a:rPr lang="en" altLang="ja-JP" dirty="0"/>
              <a:t>upplement</a:t>
            </a:r>
            <a:r>
              <a:rPr lang="en-US" altLang="ja-JP" dirty="0"/>
              <a:t>al</a:t>
            </a:r>
            <a:r>
              <a:rPr lang="en" altLang="ja-JP" dirty="0"/>
              <a:t> Figure </a:t>
            </a:r>
            <a:endParaRPr lang="ja-JP" altLang="en-US" dirty="0"/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7F7A71C3-76DD-4562-AE11-E777E6F5B703}"/>
              </a:ext>
            </a:extLst>
          </p:cNvPr>
          <p:cNvCxnSpPr/>
          <p:nvPr/>
        </p:nvCxnSpPr>
        <p:spPr>
          <a:xfrm>
            <a:off x="1016454" y="4137457"/>
            <a:ext cx="3016469" cy="0"/>
          </a:xfrm>
          <a:prstGeom prst="line">
            <a:avLst/>
          </a:prstGeom>
          <a:ln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7CBC36C-E5D2-4038-B75E-54110F4C6EA7}"/>
              </a:ext>
            </a:extLst>
          </p:cNvPr>
          <p:cNvSpPr txBox="1"/>
          <p:nvPr/>
        </p:nvSpPr>
        <p:spPr>
          <a:xfrm>
            <a:off x="1995427" y="4157268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epoch</a:t>
            </a:r>
            <a:endParaRPr kumimoji="1" lang="ja-JP" altLang="en-US" sz="12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000E739-3559-4CD0-92F3-D3390488F7E0}"/>
              </a:ext>
            </a:extLst>
          </p:cNvPr>
          <p:cNvSpPr txBox="1"/>
          <p:nvPr/>
        </p:nvSpPr>
        <p:spPr>
          <a:xfrm>
            <a:off x="-71919" y="39780"/>
            <a:ext cx="1343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ctivity intensity</a:t>
            </a:r>
            <a:endParaRPr kumimoji="1" lang="ja-JP" altLang="en-US" sz="1200" dirty="0"/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27480C59-3742-436D-95BD-BF808AE386DB}"/>
              </a:ext>
            </a:extLst>
          </p:cNvPr>
          <p:cNvCxnSpPr/>
          <p:nvPr/>
        </p:nvCxnSpPr>
        <p:spPr>
          <a:xfrm>
            <a:off x="5038287" y="4157268"/>
            <a:ext cx="3016469" cy="0"/>
          </a:xfrm>
          <a:prstGeom prst="line">
            <a:avLst/>
          </a:prstGeom>
          <a:ln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3CB7356-E73C-4942-A5FC-E8BFAB9A1CCE}"/>
              </a:ext>
            </a:extLst>
          </p:cNvPr>
          <p:cNvSpPr txBox="1"/>
          <p:nvPr/>
        </p:nvSpPr>
        <p:spPr>
          <a:xfrm>
            <a:off x="6017260" y="4177079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epoch</a:t>
            </a:r>
            <a:endParaRPr kumimoji="1" lang="ja-JP" altLang="en-US" sz="1200" dirty="0"/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41E9F32E-2FF4-4B23-9AE6-8AF7FB541348}"/>
              </a:ext>
            </a:extLst>
          </p:cNvPr>
          <p:cNvCxnSpPr/>
          <p:nvPr/>
        </p:nvCxnSpPr>
        <p:spPr>
          <a:xfrm>
            <a:off x="9025636" y="4177079"/>
            <a:ext cx="3016469" cy="0"/>
          </a:xfrm>
          <a:prstGeom prst="line">
            <a:avLst/>
          </a:prstGeom>
          <a:ln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85B8BBA-848F-4D8C-8F95-15829FE64230}"/>
              </a:ext>
            </a:extLst>
          </p:cNvPr>
          <p:cNvSpPr txBox="1"/>
          <p:nvPr/>
        </p:nvSpPr>
        <p:spPr>
          <a:xfrm>
            <a:off x="10004609" y="4196890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epoch</a:t>
            </a:r>
            <a:endParaRPr kumimoji="1" lang="ja-JP" altLang="en-US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EBA897F-1D12-4694-8FEC-F20471D1B585}"/>
              </a:ext>
            </a:extLst>
          </p:cNvPr>
          <p:cNvSpPr txBox="1"/>
          <p:nvPr/>
        </p:nvSpPr>
        <p:spPr>
          <a:xfrm>
            <a:off x="3746014" y="73262"/>
            <a:ext cx="1343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ctivity intensity</a:t>
            </a:r>
            <a:endParaRPr kumimoji="1" lang="ja-JP" altLang="en-US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273DD1C-049E-4DA1-BDA7-2EB2BEC6CBF0}"/>
              </a:ext>
            </a:extLst>
          </p:cNvPr>
          <p:cNvSpPr txBox="1"/>
          <p:nvPr/>
        </p:nvSpPr>
        <p:spPr>
          <a:xfrm>
            <a:off x="7733910" y="48863"/>
            <a:ext cx="1343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ctivity intensity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7136441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</TotalTime>
  <Words>75</Words>
  <Application>Microsoft Macintosh PowerPoint</Application>
  <PresentationFormat>ワイド画面</PresentationFormat>
  <Paragraphs>4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小児におけるFS-760の妥当性検討</dc:title>
  <dc:creator>榎本 みのり</dc:creator>
  <cp:lastModifiedBy>榎本 みのり</cp:lastModifiedBy>
  <cp:revision>2</cp:revision>
  <dcterms:created xsi:type="dcterms:W3CDTF">2021-05-10T02:53:41Z</dcterms:created>
  <dcterms:modified xsi:type="dcterms:W3CDTF">2022-04-04T03:59:09Z</dcterms:modified>
</cp:coreProperties>
</file>